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3860463" cy="8658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FF"/>
    <a:srgbClr val="FF66FF"/>
    <a:srgbClr val="FF9999"/>
    <a:srgbClr val="FF99FF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56" d="100"/>
          <a:sy n="56" d="100"/>
        </p:scale>
        <p:origin x="108" y="7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32558" y="1416983"/>
            <a:ext cx="10395347" cy="3014345"/>
          </a:xfrm>
        </p:spPr>
        <p:txBody>
          <a:bodyPr anchor="b"/>
          <a:lstStyle>
            <a:lvl1pPr algn="ctr">
              <a:defRPr sz="682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32558" y="4547573"/>
            <a:ext cx="10395347" cy="2090400"/>
          </a:xfrm>
        </p:spPr>
        <p:txBody>
          <a:bodyPr/>
          <a:lstStyle>
            <a:lvl1pPr marL="0" indent="0" algn="ctr">
              <a:buNone/>
              <a:defRPr sz="2728"/>
            </a:lvl1pPr>
            <a:lvl2pPr marL="519745" indent="0" algn="ctr">
              <a:buNone/>
              <a:defRPr sz="2274"/>
            </a:lvl2pPr>
            <a:lvl3pPr marL="1039490" indent="0" algn="ctr">
              <a:buNone/>
              <a:defRPr sz="2046"/>
            </a:lvl3pPr>
            <a:lvl4pPr marL="1559235" indent="0" algn="ctr">
              <a:buNone/>
              <a:defRPr sz="1819"/>
            </a:lvl4pPr>
            <a:lvl5pPr marL="2078980" indent="0" algn="ctr">
              <a:buNone/>
              <a:defRPr sz="1819"/>
            </a:lvl5pPr>
            <a:lvl6pPr marL="2598725" indent="0" algn="ctr">
              <a:buNone/>
              <a:defRPr sz="1819"/>
            </a:lvl6pPr>
            <a:lvl7pPr marL="3118470" indent="0" algn="ctr">
              <a:buNone/>
              <a:defRPr sz="1819"/>
            </a:lvl7pPr>
            <a:lvl8pPr marL="3638215" indent="0" algn="ctr">
              <a:buNone/>
              <a:defRPr sz="1819"/>
            </a:lvl8pPr>
            <a:lvl9pPr marL="4157960" indent="0" algn="ctr">
              <a:buNone/>
              <a:defRPr sz="1819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767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37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918894" y="460971"/>
            <a:ext cx="2988662" cy="733744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52907" y="460971"/>
            <a:ext cx="8792731" cy="733744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27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531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5688" y="2158545"/>
            <a:ext cx="11954649" cy="3601580"/>
          </a:xfrm>
        </p:spPr>
        <p:txBody>
          <a:bodyPr anchor="b"/>
          <a:lstStyle>
            <a:lvl1pPr>
              <a:defRPr sz="682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5688" y="5794198"/>
            <a:ext cx="11954649" cy="1893986"/>
          </a:xfrm>
        </p:spPr>
        <p:txBody>
          <a:bodyPr/>
          <a:lstStyle>
            <a:lvl1pPr marL="0" indent="0">
              <a:buNone/>
              <a:defRPr sz="2728">
                <a:solidFill>
                  <a:schemeClr val="tx1">
                    <a:tint val="75000"/>
                  </a:schemeClr>
                </a:solidFill>
              </a:defRPr>
            </a:lvl1pPr>
            <a:lvl2pPr marL="519745" indent="0">
              <a:buNone/>
              <a:defRPr sz="2274">
                <a:solidFill>
                  <a:schemeClr val="tx1">
                    <a:tint val="75000"/>
                  </a:schemeClr>
                </a:solidFill>
              </a:defRPr>
            </a:lvl2pPr>
            <a:lvl3pPr marL="1039490" indent="0">
              <a:buNone/>
              <a:defRPr sz="2046">
                <a:solidFill>
                  <a:schemeClr val="tx1">
                    <a:tint val="75000"/>
                  </a:schemeClr>
                </a:solidFill>
              </a:defRPr>
            </a:lvl3pPr>
            <a:lvl4pPr marL="1559235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4pPr>
            <a:lvl5pPr marL="2078980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5pPr>
            <a:lvl6pPr marL="2598725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6pPr>
            <a:lvl7pPr marL="3118470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7pPr>
            <a:lvl8pPr marL="3638215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8pPr>
            <a:lvl9pPr marL="4157960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644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52907" y="2304852"/>
            <a:ext cx="5890697" cy="549356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16859" y="2304852"/>
            <a:ext cx="5890697" cy="549356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201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4712" y="460971"/>
            <a:ext cx="11954649" cy="167352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4713" y="2122468"/>
            <a:ext cx="5863625" cy="1040189"/>
          </a:xfrm>
        </p:spPr>
        <p:txBody>
          <a:bodyPr anchor="b"/>
          <a:lstStyle>
            <a:lvl1pPr marL="0" indent="0">
              <a:buNone/>
              <a:defRPr sz="2728" b="1"/>
            </a:lvl1pPr>
            <a:lvl2pPr marL="519745" indent="0">
              <a:buNone/>
              <a:defRPr sz="2274" b="1"/>
            </a:lvl2pPr>
            <a:lvl3pPr marL="1039490" indent="0">
              <a:buNone/>
              <a:defRPr sz="2046" b="1"/>
            </a:lvl3pPr>
            <a:lvl4pPr marL="1559235" indent="0">
              <a:buNone/>
              <a:defRPr sz="1819" b="1"/>
            </a:lvl4pPr>
            <a:lvl5pPr marL="2078980" indent="0">
              <a:buNone/>
              <a:defRPr sz="1819" b="1"/>
            </a:lvl5pPr>
            <a:lvl6pPr marL="2598725" indent="0">
              <a:buNone/>
              <a:defRPr sz="1819" b="1"/>
            </a:lvl6pPr>
            <a:lvl7pPr marL="3118470" indent="0">
              <a:buNone/>
              <a:defRPr sz="1819" b="1"/>
            </a:lvl7pPr>
            <a:lvl8pPr marL="3638215" indent="0">
              <a:buNone/>
              <a:defRPr sz="1819" b="1"/>
            </a:lvl8pPr>
            <a:lvl9pPr marL="4157960" indent="0">
              <a:buNone/>
              <a:defRPr sz="1819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54713" y="3162657"/>
            <a:ext cx="5863625" cy="465179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016859" y="2122468"/>
            <a:ext cx="5892502" cy="1040189"/>
          </a:xfrm>
        </p:spPr>
        <p:txBody>
          <a:bodyPr anchor="b"/>
          <a:lstStyle>
            <a:lvl1pPr marL="0" indent="0">
              <a:buNone/>
              <a:defRPr sz="2728" b="1"/>
            </a:lvl1pPr>
            <a:lvl2pPr marL="519745" indent="0">
              <a:buNone/>
              <a:defRPr sz="2274" b="1"/>
            </a:lvl2pPr>
            <a:lvl3pPr marL="1039490" indent="0">
              <a:buNone/>
              <a:defRPr sz="2046" b="1"/>
            </a:lvl3pPr>
            <a:lvl4pPr marL="1559235" indent="0">
              <a:buNone/>
              <a:defRPr sz="1819" b="1"/>
            </a:lvl4pPr>
            <a:lvl5pPr marL="2078980" indent="0">
              <a:buNone/>
              <a:defRPr sz="1819" b="1"/>
            </a:lvl5pPr>
            <a:lvl6pPr marL="2598725" indent="0">
              <a:buNone/>
              <a:defRPr sz="1819" b="1"/>
            </a:lvl6pPr>
            <a:lvl7pPr marL="3118470" indent="0">
              <a:buNone/>
              <a:defRPr sz="1819" b="1"/>
            </a:lvl7pPr>
            <a:lvl8pPr marL="3638215" indent="0">
              <a:buNone/>
              <a:defRPr sz="1819" b="1"/>
            </a:lvl8pPr>
            <a:lvl9pPr marL="4157960" indent="0">
              <a:buNone/>
              <a:defRPr sz="1819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016859" y="3162657"/>
            <a:ext cx="5892502" cy="465179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879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837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750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4713" y="577215"/>
            <a:ext cx="4470360" cy="2020253"/>
          </a:xfrm>
        </p:spPr>
        <p:txBody>
          <a:bodyPr anchor="b"/>
          <a:lstStyle>
            <a:lvl1pPr>
              <a:defRPr sz="363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92502" y="1246624"/>
            <a:ext cx="7016859" cy="6152952"/>
          </a:xfrm>
        </p:spPr>
        <p:txBody>
          <a:bodyPr/>
          <a:lstStyle>
            <a:lvl1pPr>
              <a:defRPr sz="3638"/>
            </a:lvl1pPr>
            <a:lvl2pPr>
              <a:defRPr sz="3183"/>
            </a:lvl2pPr>
            <a:lvl3pPr>
              <a:defRPr sz="2728"/>
            </a:lvl3pPr>
            <a:lvl4pPr>
              <a:defRPr sz="2274"/>
            </a:lvl4pPr>
            <a:lvl5pPr>
              <a:defRPr sz="2274"/>
            </a:lvl5pPr>
            <a:lvl6pPr>
              <a:defRPr sz="2274"/>
            </a:lvl6pPr>
            <a:lvl7pPr>
              <a:defRPr sz="2274"/>
            </a:lvl7pPr>
            <a:lvl8pPr>
              <a:defRPr sz="2274"/>
            </a:lvl8pPr>
            <a:lvl9pPr>
              <a:defRPr sz="2274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4713" y="2597467"/>
            <a:ext cx="4470360" cy="4812130"/>
          </a:xfrm>
        </p:spPr>
        <p:txBody>
          <a:bodyPr/>
          <a:lstStyle>
            <a:lvl1pPr marL="0" indent="0">
              <a:buNone/>
              <a:defRPr sz="1819"/>
            </a:lvl1pPr>
            <a:lvl2pPr marL="519745" indent="0">
              <a:buNone/>
              <a:defRPr sz="1592"/>
            </a:lvl2pPr>
            <a:lvl3pPr marL="1039490" indent="0">
              <a:buNone/>
              <a:defRPr sz="1364"/>
            </a:lvl3pPr>
            <a:lvl4pPr marL="1559235" indent="0">
              <a:buNone/>
              <a:defRPr sz="1137"/>
            </a:lvl4pPr>
            <a:lvl5pPr marL="2078980" indent="0">
              <a:buNone/>
              <a:defRPr sz="1137"/>
            </a:lvl5pPr>
            <a:lvl6pPr marL="2598725" indent="0">
              <a:buNone/>
              <a:defRPr sz="1137"/>
            </a:lvl6pPr>
            <a:lvl7pPr marL="3118470" indent="0">
              <a:buNone/>
              <a:defRPr sz="1137"/>
            </a:lvl7pPr>
            <a:lvl8pPr marL="3638215" indent="0">
              <a:buNone/>
              <a:defRPr sz="1137"/>
            </a:lvl8pPr>
            <a:lvl9pPr marL="4157960" indent="0">
              <a:buNone/>
              <a:defRPr sz="113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026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4713" y="577215"/>
            <a:ext cx="4470360" cy="2020253"/>
          </a:xfrm>
        </p:spPr>
        <p:txBody>
          <a:bodyPr anchor="b"/>
          <a:lstStyle>
            <a:lvl1pPr>
              <a:defRPr sz="363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92502" y="1246624"/>
            <a:ext cx="7016859" cy="6152952"/>
          </a:xfrm>
        </p:spPr>
        <p:txBody>
          <a:bodyPr anchor="t"/>
          <a:lstStyle>
            <a:lvl1pPr marL="0" indent="0">
              <a:buNone/>
              <a:defRPr sz="3638"/>
            </a:lvl1pPr>
            <a:lvl2pPr marL="519745" indent="0">
              <a:buNone/>
              <a:defRPr sz="3183"/>
            </a:lvl2pPr>
            <a:lvl3pPr marL="1039490" indent="0">
              <a:buNone/>
              <a:defRPr sz="2728"/>
            </a:lvl3pPr>
            <a:lvl4pPr marL="1559235" indent="0">
              <a:buNone/>
              <a:defRPr sz="2274"/>
            </a:lvl4pPr>
            <a:lvl5pPr marL="2078980" indent="0">
              <a:buNone/>
              <a:defRPr sz="2274"/>
            </a:lvl5pPr>
            <a:lvl6pPr marL="2598725" indent="0">
              <a:buNone/>
              <a:defRPr sz="2274"/>
            </a:lvl6pPr>
            <a:lvl7pPr marL="3118470" indent="0">
              <a:buNone/>
              <a:defRPr sz="2274"/>
            </a:lvl7pPr>
            <a:lvl8pPr marL="3638215" indent="0">
              <a:buNone/>
              <a:defRPr sz="2274"/>
            </a:lvl8pPr>
            <a:lvl9pPr marL="4157960" indent="0">
              <a:buNone/>
              <a:defRPr sz="2274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4713" y="2597467"/>
            <a:ext cx="4470360" cy="4812130"/>
          </a:xfrm>
        </p:spPr>
        <p:txBody>
          <a:bodyPr/>
          <a:lstStyle>
            <a:lvl1pPr marL="0" indent="0">
              <a:buNone/>
              <a:defRPr sz="1819"/>
            </a:lvl1pPr>
            <a:lvl2pPr marL="519745" indent="0">
              <a:buNone/>
              <a:defRPr sz="1592"/>
            </a:lvl2pPr>
            <a:lvl3pPr marL="1039490" indent="0">
              <a:buNone/>
              <a:defRPr sz="1364"/>
            </a:lvl3pPr>
            <a:lvl4pPr marL="1559235" indent="0">
              <a:buNone/>
              <a:defRPr sz="1137"/>
            </a:lvl4pPr>
            <a:lvl5pPr marL="2078980" indent="0">
              <a:buNone/>
              <a:defRPr sz="1137"/>
            </a:lvl5pPr>
            <a:lvl6pPr marL="2598725" indent="0">
              <a:buNone/>
              <a:defRPr sz="1137"/>
            </a:lvl6pPr>
            <a:lvl7pPr marL="3118470" indent="0">
              <a:buNone/>
              <a:defRPr sz="1137"/>
            </a:lvl7pPr>
            <a:lvl8pPr marL="3638215" indent="0">
              <a:buNone/>
              <a:defRPr sz="1137"/>
            </a:lvl8pPr>
            <a:lvl9pPr marL="4157960" indent="0">
              <a:buNone/>
              <a:defRPr sz="113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798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52907" y="460971"/>
            <a:ext cx="11954649" cy="16735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2907" y="2304852"/>
            <a:ext cx="11954649" cy="54935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52907" y="8024893"/>
            <a:ext cx="3118604" cy="4609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11DBD-F7F9-40C2-9CD7-122DB5A0A572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91279" y="8024893"/>
            <a:ext cx="4677906" cy="4609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788952" y="8024893"/>
            <a:ext cx="3118604" cy="4609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88D2E-155B-4ADE-861B-02147AB21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952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39490" rtl="0" eaLnBrk="1" latinLnBrk="0" hangingPunct="1">
        <a:lnSpc>
          <a:spcPct val="90000"/>
        </a:lnSpc>
        <a:spcBef>
          <a:spcPct val="0"/>
        </a:spcBef>
        <a:buNone/>
        <a:defRPr sz="500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9872" indent="-259872" algn="l" defTabSz="1039490" rtl="0" eaLnBrk="1" latinLnBrk="0" hangingPunct="1">
        <a:lnSpc>
          <a:spcPct val="90000"/>
        </a:lnSpc>
        <a:spcBef>
          <a:spcPts val="1137"/>
        </a:spcBef>
        <a:buFont typeface="Arial" panose="020B0604020202020204" pitchFamily="34" charset="0"/>
        <a:buChar char="•"/>
        <a:defRPr sz="3183" kern="1200">
          <a:solidFill>
            <a:schemeClr val="tx1"/>
          </a:solidFill>
          <a:latin typeface="+mn-lt"/>
          <a:ea typeface="+mn-ea"/>
          <a:cs typeface="+mn-cs"/>
        </a:defRPr>
      </a:lvl1pPr>
      <a:lvl2pPr marL="779617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728" kern="1200">
          <a:solidFill>
            <a:schemeClr val="tx1"/>
          </a:solidFill>
          <a:latin typeface="+mn-lt"/>
          <a:ea typeface="+mn-ea"/>
          <a:cs typeface="+mn-cs"/>
        </a:defRPr>
      </a:lvl2pPr>
      <a:lvl3pPr marL="1299362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274" kern="1200">
          <a:solidFill>
            <a:schemeClr val="tx1"/>
          </a:solidFill>
          <a:latin typeface="+mn-lt"/>
          <a:ea typeface="+mn-ea"/>
          <a:cs typeface="+mn-cs"/>
        </a:defRPr>
      </a:lvl3pPr>
      <a:lvl4pPr marL="1819107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4pPr>
      <a:lvl5pPr marL="2338852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5pPr>
      <a:lvl6pPr marL="2858597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6pPr>
      <a:lvl7pPr marL="3378342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7pPr>
      <a:lvl8pPr marL="3898087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8pPr>
      <a:lvl9pPr marL="4417832" indent="-259872" algn="l" defTabSz="1039490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1pPr>
      <a:lvl2pPr marL="519745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2pPr>
      <a:lvl3pPr marL="1039490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3pPr>
      <a:lvl4pPr marL="1559235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4pPr>
      <a:lvl5pPr marL="2078980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5pPr>
      <a:lvl6pPr marL="2598725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6pPr>
      <a:lvl7pPr marL="3118470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7pPr>
      <a:lvl8pPr marL="3638215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8pPr>
      <a:lvl9pPr marL="4157960" algn="l" defTabSz="1039490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8" name="Group 447"/>
          <p:cNvGrpSpPr/>
          <p:nvPr/>
        </p:nvGrpSpPr>
        <p:grpSpPr>
          <a:xfrm>
            <a:off x="5660990" y="59431"/>
            <a:ext cx="3549396" cy="8488859"/>
            <a:chOff x="5660990" y="59431"/>
            <a:chExt cx="3549396" cy="8488859"/>
          </a:xfrm>
        </p:grpSpPr>
        <p:grpSp>
          <p:nvGrpSpPr>
            <p:cNvPr id="257" name="Group 256"/>
            <p:cNvGrpSpPr/>
            <p:nvPr/>
          </p:nvGrpSpPr>
          <p:grpSpPr>
            <a:xfrm>
              <a:off x="6212023" y="6331166"/>
              <a:ext cx="2297434" cy="2217124"/>
              <a:chOff x="5482382" y="3556742"/>
              <a:chExt cx="3191866" cy="2028824"/>
            </a:xfrm>
          </p:grpSpPr>
          <p:sp>
            <p:nvSpPr>
              <p:cNvPr id="258" name="Rounded Rectangle 257"/>
              <p:cNvSpPr/>
              <p:nvPr/>
            </p:nvSpPr>
            <p:spPr>
              <a:xfrm>
                <a:off x="5482382" y="3556742"/>
                <a:ext cx="3191866" cy="2028824"/>
              </a:xfrm>
              <a:prstGeom prst="roundRect">
                <a:avLst/>
              </a:prstGeom>
              <a:solidFill>
                <a:schemeClr val="bg1"/>
              </a:solidFill>
              <a:ln w="28575">
                <a:solidFill>
                  <a:schemeClr val="tx1">
                    <a:lumMod val="95000"/>
                    <a:lumOff val="5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numCol="1" rtlCol="0" anchor="ctr"/>
              <a:lstStyle/>
              <a:p>
                <a:pPr algn="ctr"/>
                <a:r>
                  <a:rPr lang="nb-NO" sz="20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mor </a:t>
                </a:r>
              </a:p>
              <a:p>
                <a:pPr algn="ctr"/>
                <a:r>
                  <a:rPr lang="nb-NO" sz="20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 </a:t>
                </a:r>
                <a:r>
                  <a:rPr lang="nb-NO" sz="2000" b="1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pression</a:t>
                </a:r>
                <a:r>
                  <a:rPr lang="nb-NO" sz="20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b-NO" sz="2000" b="1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alysis</a:t>
                </a:r>
                <a:endParaRPr lang="nb-NO" sz="2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b-NO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 </a:t>
                </a:r>
                <a:r>
                  <a:rPr lang="nb-NO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lected</a:t>
                </a:r>
                <a:r>
                  <a:rPr lang="nb-NO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genes</a:t>
                </a:r>
                <a:endParaRPr lang="nb-NO" sz="2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nb-NO" sz="2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b-NO" sz="12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pPr algn="ctr"/>
                <a:endParaRPr lang="nb-NO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nb-NO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59" name="Picture 25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640" t="13390" r="12974" b="27994"/>
              <a:stretch/>
            </p:blipFill>
            <p:spPr>
              <a:xfrm rot="16200000">
                <a:off x="6799233" y="4213388"/>
                <a:ext cx="851545" cy="1790386"/>
              </a:xfrm>
              <a:prstGeom prst="rect">
                <a:avLst/>
              </a:prstGeom>
            </p:spPr>
          </p:pic>
        </p:grpSp>
        <p:sp>
          <p:nvSpPr>
            <p:cNvPr id="261" name="TextBox 260"/>
            <p:cNvSpPr txBox="1"/>
            <p:nvPr/>
          </p:nvSpPr>
          <p:spPr>
            <a:xfrm>
              <a:off x="6616162" y="59431"/>
              <a:ext cx="167225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 </a:t>
              </a:r>
              <a:r>
                <a:rPr lang="nb-NO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0" name="Straight Arrow Connector 259"/>
            <p:cNvCxnSpPr>
              <a:stCxn id="278" idx="2"/>
              <a:endCxn id="258" idx="0"/>
            </p:cNvCxnSpPr>
            <p:nvPr/>
          </p:nvCxnSpPr>
          <p:spPr>
            <a:xfrm>
              <a:off x="6548762" y="2534316"/>
              <a:ext cx="811978" cy="37968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Straight Arrow Connector 279"/>
            <p:cNvCxnSpPr>
              <a:stCxn id="279" idx="2"/>
              <a:endCxn id="258" idx="0"/>
            </p:cNvCxnSpPr>
            <p:nvPr/>
          </p:nvCxnSpPr>
          <p:spPr>
            <a:xfrm flipH="1">
              <a:off x="7360740" y="2527966"/>
              <a:ext cx="966248" cy="38032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" name="Group 25"/>
            <p:cNvGrpSpPr/>
            <p:nvPr/>
          </p:nvGrpSpPr>
          <p:grpSpPr>
            <a:xfrm>
              <a:off x="5660990" y="492792"/>
              <a:ext cx="3549396" cy="2041524"/>
              <a:chOff x="288473" y="409576"/>
              <a:chExt cx="3549396" cy="2041524"/>
            </a:xfrm>
          </p:grpSpPr>
          <p:sp>
            <p:nvSpPr>
              <p:cNvPr id="256" name="Rounded Rectangle 255"/>
              <p:cNvSpPr/>
              <p:nvPr/>
            </p:nvSpPr>
            <p:spPr>
              <a:xfrm>
                <a:off x="288473" y="409576"/>
                <a:ext cx="3549396" cy="2028824"/>
              </a:xfrm>
              <a:prstGeom prst="roundRect">
                <a:avLst/>
              </a:prstGeom>
              <a:solidFill>
                <a:schemeClr val="bg1"/>
              </a:solidFill>
              <a:ln w="285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numCol="2" rtlCol="0" anchor="ctr"/>
              <a:lstStyle/>
              <a:p>
                <a:pPr algn="ctr"/>
                <a:endParaRPr lang="nb-NO" sz="2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b-NO" sz="20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S98.06</a:t>
                </a:r>
              </a:p>
              <a:p>
                <a:pPr algn="ctr"/>
                <a:r>
                  <a:rPr lang="nb-NO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=6)</a:t>
                </a:r>
              </a:p>
              <a:p>
                <a:pPr algn="ctr"/>
                <a:r>
                  <a:rPr lang="nb-NO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treated</a:t>
                </a:r>
                <a:endParaRPr lang="nb-NO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nb-NO" sz="2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nb-NO" sz="2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nb-NO" sz="2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nb-NO" sz="2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b-NO" sz="20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S98.12</a:t>
                </a:r>
                <a:endParaRPr lang="nb-NO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b-NO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=6)</a:t>
                </a:r>
              </a:p>
              <a:p>
                <a:pPr algn="ctr"/>
                <a:r>
                  <a:rPr lang="nb-NO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treated</a:t>
                </a:r>
                <a:endParaRPr lang="nb-NO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b-NO" sz="12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pPr algn="ctr"/>
                <a:endParaRPr lang="nb-NO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nb-NO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Rounded Rectangle 277"/>
              <p:cNvSpPr/>
              <p:nvPr/>
            </p:nvSpPr>
            <p:spPr>
              <a:xfrm>
                <a:off x="335806" y="422276"/>
                <a:ext cx="1680877" cy="2028824"/>
              </a:xfrm>
              <a:prstGeom prst="round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9" name="Rounded Rectangle 278"/>
              <p:cNvSpPr/>
              <p:nvPr/>
            </p:nvSpPr>
            <p:spPr>
              <a:xfrm>
                <a:off x="2114032" y="415926"/>
                <a:ext cx="1680877" cy="2028824"/>
              </a:xfrm>
              <a:prstGeom prst="round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55" name="Group 354"/>
              <p:cNvGrpSpPr/>
              <p:nvPr/>
            </p:nvGrpSpPr>
            <p:grpSpPr>
              <a:xfrm>
                <a:off x="2082753" y="1798447"/>
                <a:ext cx="1490742" cy="625942"/>
                <a:chOff x="633274" y="3149330"/>
                <a:chExt cx="1490742" cy="625942"/>
              </a:xfrm>
            </p:grpSpPr>
            <p:sp>
              <p:nvSpPr>
                <p:cNvPr id="356" name="Freeform 355"/>
                <p:cNvSpPr/>
                <p:nvPr/>
              </p:nvSpPr>
              <p:spPr>
                <a:xfrm rot="4097676">
                  <a:off x="1849570" y="3203262"/>
                  <a:ext cx="200464" cy="206690"/>
                </a:xfrm>
                <a:custGeom>
                  <a:avLst/>
                  <a:gdLst>
                    <a:gd name="connsiteX0" fmla="*/ 223083 w 250515"/>
                    <a:gd name="connsiteY0" fmla="*/ 252049 h 262707"/>
                    <a:gd name="connsiteX1" fmla="*/ 21915 w 250515"/>
                    <a:gd name="connsiteY1" fmla="*/ 233761 h 262707"/>
                    <a:gd name="connsiteX2" fmla="*/ 31059 w 250515"/>
                    <a:gd name="connsiteY2" fmla="*/ 5161 h 262707"/>
                    <a:gd name="connsiteX3" fmla="*/ 250515 w 250515"/>
                    <a:gd name="connsiteY3" fmla="*/ 96601 h 26270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250515" h="262707">
                      <a:moveTo>
                        <a:pt x="223083" y="252049"/>
                      </a:moveTo>
                      <a:cubicBezTo>
                        <a:pt x="138501" y="263479"/>
                        <a:pt x="53919" y="274909"/>
                        <a:pt x="21915" y="233761"/>
                      </a:cubicBezTo>
                      <a:cubicBezTo>
                        <a:pt x="-10089" y="192613"/>
                        <a:pt x="-7041" y="28021"/>
                        <a:pt x="31059" y="5161"/>
                      </a:cubicBezTo>
                      <a:cubicBezTo>
                        <a:pt x="69159" y="-17699"/>
                        <a:pt x="159837" y="39451"/>
                        <a:pt x="250515" y="96601"/>
                      </a:cubicBezTo>
                    </a:path>
                  </a:pathLst>
                </a:custGeom>
                <a:solidFill>
                  <a:srgbClr val="FF00FF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7" name="Chord 356"/>
                <p:cNvSpPr/>
                <p:nvPr/>
              </p:nvSpPr>
              <p:spPr>
                <a:xfrm rot="6623560">
                  <a:off x="1301346" y="2952601"/>
                  <a:ext cx="625942" cy="1019399"/>
                </a:xfrm>
                <a:prstGeom prst="chord">
                  <a:avLst/>
                </a:prstGeom>
                <a:solidFill>
                  <a:srgbClr val="FF66FF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8" name="Freeform 357"/>
                <p:cNvSpPr/>
                <p:nvPr/>
              </p:nvSpPr>
              <p:spPr>
                <a:xfrm rot="3137593">
                  <a:off x="1790553" y="3230837"/>
                  <a:ext cx="199247" cy="206689"/>
                </a:xfrm>
                <a:custGeom>
                  <a:avLst/>
                  <a:gdLst>
                    <a:gd name="connsiteX0" fmla="*/ 223083 w 250515"/>
                    <a:gd name="connsiteY0" fmla="*/ 252049 h 262707"/>
                    <a:gd name="connsiteX1" fmla="*/ 21915 w 250515"/>
                    <a:gd name="connsiteY1" fmla="*/ 233761 h 262707"/>
                    <a:gd name="connsiteX2" fmla="*/ 31059 w 250515"/>
                    <a:gd name="connsiteY2" fmla="*/ 5161 h 262707"/>
                    <a:gd name="connsiteX3" fmla="*/ 250515 w 250515"/>
                    <a:gd name="connsiteY3" fmla="*/ 96601 h 26270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250515" h="262707">
                      <a:moveTo>
                        <a:pt x="223083" y="252049"/>
                      </a:moveTo>
                      <a:cubicBezTo>
                        <a:pt x="138501" y="263479"/>
                        <a:pt x="53919" y="274909"/>
                        <a:pt x="21915" y="233761"/>
                      </a:cubicBezTo>
                      <a:cubicBezTo>
                        <a:pt x="-10089" y="192613"/>
                        <a:pt x="-7041" y="28021"/>
                        <a:pt x="31059" y="5161"/>
                      </a:cubicBezTo>
                      <a:cubicBezTo>
                        <a:pt x="69159" y="-17699"/>
                        <a:pt x="159837" y="39451"/>
                        <a:pt x="250515" y="96601"/>
                      </a:cubicBezTo>
                    </a:path>
                  </a:pathLst>
                </a:custGeom>
                <a:solidFill>
                  <a:srgbClr val="FF00FF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7" name="Freeform 466"/>
                <p:cNvSpPr/>
                <p:nvPr/>
              </p:nvSpPr>
              <p:spPr>
                <a:xfrm rot="2657669">
                  <a:off x="633274" y="3267058"/>
                  <a:ext cx="779370" cy="131798"/>
                </a:xfrm>
                <a:custGeom>
                  <a:avLst/>
                  <a:gdLst>
                    <a:gd name="connsiteX0" fmla="*/ 0 w 1417320"/>
                    <a:gd name="connsiteY0" fmla="*/ 284539 h 383156"/>
                    <a:gd name="connsiteX1" fmla="*/ 402336 w 1417320"/>
                    <a:gd name="connsiteY1" fmla="*/ 1075 h 383156"/>
                    <a:gd name="connsiteX2" fmla="*/ 923544 w 1417320"/>
                    <a:gd name="connsiteY2" fmla="*/ 375979 h 383156"/>
                    <a:gd name="connsiteX3" fmla="*/ 1417320 w 1417320"/>
                    <a:gd name="connsiteY3" fmla="*/ 257107 h 383156"/>
                    <a:gd name="connsiteX4" fmla="*/ 1417320 w 1417320"/>
                    <a:gd name="connsiteY4" fmla="*/ 257107 h 38315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417320" h="383156">
                      <a:moveTo>
                        <a:pt x="0" y="284539"/>
                      </a:moveTo>
                      <a:cubicBezTo>
                        <a:pt x="124206" y="135187"/>
                        <a:pt x="248412" y="-14165"/>
                        <a:pt x="402336" y="1075"/>
                      </a:cubicBezTo>
                      <a:cubicBezTo>
                        <a:pt x="556260" y="16315"/>
                        <a:pt x="754380" y="333307"/>
                        <a:pt x="923544" y="375979"/>
                      </a:cubicBezTo>
                      <a:cubicBezTo>
                        <a:pt x="1092708" y="418651"/>
                        <a:pt x="1417320" y="257107"/>
                        <a:pt x="1417320" y="257107"/>
                      </a:cubicBezTo>
                      <a:lnTo>
                        <a:pt x="1417320" y="257107"/>
                      </a:ln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8" name="Oval 467"/>
                <p:cNvSpPr/>
                <p:nvPr/>
              </p:nvSpPr>
              <p:spPr>
                <a:xfrm>
                  <a:off x="1950244" y="3437953"/>
                  <a:ext cx="45719" cy="45719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69" name="Group 468"/>
              <p:cNvGrpSpPr/>
              <p:nvPr/>
            </p:nvGrpSpPr>
            <p:grpSpPr>
              <a:xfrm>
                <a:off x="374754" y="1772824"/>
                <a:ext cx="1490742" cy="625942"/>
                <a:chOff x="633274" y="3149330"/>
                <a:chExt cx="1490742" cy="625942"/>
              </a:xfrm>
            </p:grpSpPr>
            <p:sp>
              <p:nvSpPr>
                <p:cNvPr id="471" name="Freeform 470"/>
                <p:cNvSpPr/>
                <p:nvPr/>
              </p:nvSpPr>
              <p:spPr>
                <a:xfrm rot="4097676">
                  <a:off x="1849570" y="3203262"/>
                  <a:ext cx="200464" cy="206690"/>
                </a:xfrm>
                <a:custGeom>
                  <a:avLst/>
                  <a:gdLst>
                    <a:gd name="connsiteX0" fmla="*/ 223083 w 250515"/>
                    <a:gd name="connsiteY0" fmla="*/ 252049 h 262707"/>
                    <a:gd name="connsiteX1" fmla="*/ 21915 w 250515"/>
                    <a:gd name="connsiteY1" fmla="*/ 233761 h 262707"/>
                    <a:gd name="connsiteX2" fmla="*/ 31059 w 250515"/>
                    <a:gd name="connsiteY2" fmla="*/ 5161 h 262707"/>
                    <a:gd name="connsiteX3" fmla="*/ 250515 w 250515"/>
                    <a:gd name="connsiteY3" fmla="*/ 96601 h 26270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250515" h="262707">
                      <a:moveTo>
                        <a:pt x="223083" y="252049"/>
                      </a:moveTo>
                      <a:cubicBezTo>
                        <a:pt x="138501" y="263479"/>
                        <a:pt x="53919" y="274909"/>
                        <a:pt x="21915" y="233761"/>
                      </a:cubicBezTo>
                      <a:cubicBezTo>
                        <a:pt x="-10089" y="192613"/>
                        <a:pt x="-7041" y="28021"/>
                        <a:pt x="31059" y="5161"/>
                      </a:cubicBezTo>
                      <a:cubicBezTo>
                        <a:pt x="69159" y="-17699"/>
                        <a:pt x="159837" y="39451"/>
                        <a:pt x="250515" y="96601"/>
                      </a:cubicBezTo>
                    </a:path>
                  </a:pathLst>
                </a:custGeom>
                <a:solidFill>
                  <a:schemeClr val="accent5">
                    <a:lumMod val="75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2" name="Chord 471"/>
                <p:cNvSpPr/>
                <p:nvPr/>
              </p:nvSpPr>
              <p:spPr>
                <a:xfrm rot="6623560">
                  <a:off x="1301346" y="2952601"/>
                  <a:ext cx="625942" cy="1019399"/>
                </a:xfrm>
                <a:prstGeom prst="chord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3" name="Freeform 472"/>
                <p:cNvSpPr/>
                <p:nvPr/>
              </p:nvSpPr>
              <p:spPr>
                <a:xfrm rot="3137593">
                  <a:off x="1790553" y="3230837"/>
                  <a:ext cx="199247" cy="206689"/>
                </a:xfrm>
                <a:custGeom>
                  <a:avLst/>
                  <a:gdLst>
                    <a:gd name="connsiteX0" fmla="*/ 223083 w 250515"/>
                    <a:gd name="connsiteY0" fmla="*/ 252049 h 262707"/>
                    <a:gd name="connsiteX1" fmla="*/ 21915 w 250515"/>
                    <a:gd name="connsiteY1" fmla="*/ 233761 h 262707"/>
                    <a:gd name="connsiteX2" fmla="*/ 31059 w 250515"/>
                    <a:gd name="connsiteY2" fmla="*/ 5161 h 262707"/>
                    <a:gd name="connsiteX3" fmla="*/ 250515 w 250515"/>
                    <a:gd name="connsiteY3" fmla="*/ 96601 h 26270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250515" h="262707">
                      <a:moveTo>
                        <a:pt x="223083" y="252049"/>
                      </a:moveTo>
                      <a:cubicBezTo>
                        <a:pt x="138501" y="263479"/>
                        <a:pt x="53919" y="274909"/>
                        <a:pt x="21915" y="233761"/>
                      </a:cubicBezTo>
                      <a:cubicBezTo>
                        <a:pt x="-10089" y="192613"/>
                        <a:pt x="-7041" y="28021"/>
                        <a:pt x="31059" y="5161"/>
                      </a:cubicBezTo>
                      <a:cubicBezTo>
                        <a:pt x="69159" y="-17699"/>
                        <a:pt x="159837" y="39451"/>
                        <a:pt x="250515" y="96601"/>
                      </a:cubicBezTo>
                    </a:path>
                  </a:pathLst>
                </a:custGeom>
                <a:solidFill>
                  <a:schemeClr val="accent5">
                    <a:lumMod val="75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5" name="Freeform 474"/>
                <p:cNvSpPr/>
                <p:nvPr/>
              </p:nvSpPr>
              <p:spPr>
                <a:xfrm rot="2657669">
                  <a:off x="633274" y="3267058"/>
                  <a:ext cx="779370" cy="131798"/>
                </a:xfrm>
                <a:custGeom>
                  <a:avLst/>
                  <a:gdLst>
                    <a:gd name="connsiteX0" fmla="*/ 0 w 1417320"/>
                    <a:gd name="connsiteY0" fmla="*/ 284539 h 383156"/>
                    <a:gd name="connsiteX1" fmla="*/ 402336 w 1417320"/>
                    <a:gd name="connsiteY1" fmla="*/ 1075 h 383156"/>
                    <a:gd name="connsiteX2" fmla="*/ 923544 w 1417320"/>
                    <a:gd name="connsiteY2" fmla="*/ 375979 h 383156"/>
                    <a:gd name="connsiteX3" fmla="*/ 1417320 w 1417320"/>
                    <a:gd name="connsiteY3" fmla="*/ 257107 h 383156"/>
                    <a:gd name="connsiteX4" fmla="*/ 1417320 w 1417320"/>
                    <a:gd name="connsiteY4" fmla="*/ 257107 h 38315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417320" h="383156">
                      <a:moveTo>
                        <a:pt x="0" y="284539"/>
                      </a:moveTo>
                      <a:cubicBezTo>
                        <a:pt x="124206" y="135187"/>
                        <a:pt x="248412" y="-14165"/>
                        <a:pt x="402336" y="1075"/>
                      </a:cubicBezTo>
                      <a:cubicBezTo>
                        <a:pt x="556260" y="16315"/>
                        <a:pt x="754380" y="333307"/>
                        <a:pt x="923544" y="375979"/>
                      </a:cubicBezTo>
                      <a:cubicBezTo>
                        <a:pt x="1092708" y="418651"/>
                        <a:pt x="1417320" y="257107"/>
                        <a:pt x="1417320" y="257107"/>
                      </a:cubicBezTo>
                      <a:lnTo>
                        <a:pt x="1417320" y="257107"/>
                      </a:ln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6" name="Oval 475"/>
                <p:cNvSpPr/>
                <p:nvPr/>
              </p:nvSpPr>
              <p:spPr>
                <a:xfrm>
                  <a:off x="1950244" y="3437953"/>
                  <a:ext cx="45719" cy="45719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7" name="Group 26"/>
          <p:cNvGrpSpPr/>
          <p:nvPr/>
        </p:nvGrpSpPr>
        <p:grpSpPr>
          <a:xfrm>
            <a:off x="9634666" y="88863"/>
            <a:ext cx="4187943" cy="8455504"/>
            <a:chOff x="3932384" y="22129"/>
            <a:chExt cx="4187943" cy="8455504"/>
          </a:xfrm>
        </p:grpSpPr>
        <p:cxnSp>
          <p:nvCxnSpPr>
            <p:cNvPr id="477" name="Straight Arrow Connector 476"/>
            <p:cNvCxnSpPr>
              <a:stCxn id="316" idx="2"/>
              <a:endCxn id="267" idx="0"/>
            </p:cNvCxnSpPr>
            <p:nvPr/>
          </p:nvCxnSpPr>
          <p:spPr>
            <a:xfrm flipH="1">
              <a:off x="5958434" y="4373039"/>
              <a:ext cx="471413" cy="67688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8" name="Straight Arrow Connector 477"/>
            <p:cNvCxnSpPr>
              <a:stCxn id="315" idx="2"/>
              <a:endCxn id="267" idx="0"/>
            </p:cNvCxnSpPr>
            <p:nvPr/>
          </p:nvCxnSpPr>
          <p:spPr>
            <a:xfrm>
              <a:off x="5469210" y="4373039"/>
              <a:ext cx="489224" cy="67688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" name="Group 21"/>
            <p:cNvGrpSpPr/>
            <p:nvPr/>
          </p:nvGrpSpPr>
          <p:grpSpPr>
            <a:xfrm>
              <a:off x="3932384" y="22129"/>
              <a:ext cx="4187943" cy="8455504"/>
              <a:chOff x="3932384" y="22129"/>
              <a:chExt cx="4187943" cy="8455504"/>
            </a:xfrm>
          </p:grpSpPr>
          <p:sp>
            <p:nvSpPr>
              <p:cNvPr id="262" name="TextBox 261"/>
              <p:cNvSpPr txBox="1"/>
              <p:nvPr/>
            </p:nvSpPr>
            <p:spPr>
              <a:xfrm>
                <a:off x="5362263" y="22129"/>
                <a:ext cx="167225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2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periment </a:t>
                </a:r>
                <a:r>
                  <a:rPr lang="nb-NO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1" name="Group 20"/>
              <p:cNvGrpSpPr/>
              <p:nvPr/>
            </p:nvGrpSpPr>
            <p:grpSpPr>
              <a:xfrm>
                <a:off x="3932384" y="380847"/>
                <a:ext cx="4187943" cy="8096786"/>
                <a:chOff x="3932384" y="380847"/>
                <a:chExt cx="4187943" cy="8096786"/>
              </a:xfrm>
            </p:grpSpPr>
            <p:grpSp>
              <p:nvGrpSpPr>
                <p:cNvPr id="16" name="Group 15"/>
                <p:cNvGrpSpPr/>
                <p:nvPr/>
              </p:nvGrpSpPr>
              <p:grpSpPr>
                <a:xfrm>
                  <a:off x="3932384" y="5049921"/>
                  <a:ext cx="4187943" cy="708357"/>
                  <a:chOff x="3932384" y="5049921"/>
                  <a:chExt cx="4187943" cy="708357"/>
                </a:xfrm>
              </p:grpSpPr>
              <p:sp>
                <p:nvSpPr>
                  <p:cNvPr id="267" name="Rounded Rectangle 266"/>
                  <p:cNvSpPr/>
                  <p:nvPr/>
                </p:nvSpPr>
                <p:spPr>
                  <a:xfrm>
                    <a:off x="3956782" y="5049921"/>
                    <a:ext cx="4003304" cy="708357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>
                        <a:lumMod val="95000"/>
                        <a:lumOff val="5000"/>
                      </a:schemeClr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numCol="2" rtlCol="0" anchor="ctr"/>
                  <a:lstStyle/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8" name="TextBox 267"/>
                  <p:cNvSpPr txBox="1"/>
                  <p:nvPr/>
                </p:nvSpPr>
                <p:spPr>
                  <a:xfrm>
                    <a:off x="3932384" y="5080935"/>
                    <a:ext cx="4187943" cy="646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nb-NO" dirty="0" smtClean="0"/>
                      <a:t>Administration </a:t>
                    </a:r>
                    <a:r>
                      <a:rPr lang="nb-NO" dirty="0" err="1" smtClean="0"/>
                      <a:t>of</a:t>
                    </a:r>
                    <a:r>
                      <a:rPr lang="nb-NO" dirty="0" smtClean="0"/>
                      <a:t> [5-</a:t>
                    </a:r>
                    <a:r>
                      <a:rPr lang="nb-NO" baseline="30000" dirty="0" smtClean="0"/>
                      <a:t>13</a:t>
                    </a:r>
                    <a:r>
                      <a:rPr lang="nb-NO" dirty="0" smtClean="0"/>
                      <a:t>C] </a:t>
                    </a:r>
                    <a:r>
                      <a:rPr lang="nb-NO" dirty="0" err="1" smtClean="0"/>
                      <a:t>Gln</a:t>
                    </a:r>
                    <a:r>
                      <a:rPr lang="nb-NO" dirty="0" smtClean="0"/>
                      <a:t>: </a:t>
                    </a:r>
                  </a:p>
                  <a:p>
                    <a:pPr algn="ctr"/>
                    <a:r>
                      <a:rPr lang="nb-NO" dirty="0" smtClean="0"/>
                      <a:t>1.2 mg/g body </a:t>
                    </a:r>
                    <a:r>
                      <a:rPr lang="nb-NO" dirty="0" err="1" smtClean="0"/>
                      <a:t>weight</a:t>
                    </a:r>
                    <a:r>
                      <a:rPr lang="nb-NO" dirty="0" smtClean="0"/>
                      <a:t> over </a:t>
                    </a:r>
                    <a:r>
                      <a:rPr lang="nb-NO" dirty="0" err="1" smtClean="0"/>
                      <a:t>three</a:t>
                    </a:r>
                    <a:r>
                      <a:rPr lang="nb-NO" dirty="0" smtClean="0"/>
                      <a:t> </a:t>
                    </a:r>
                    <a:r>
                      <a:rPr lang="nb-NO" dirty="0" err="1" smtClean="0"/>
                      <a:t>hours</a:t>
                    </a:r>
                    <a:endParaRPr lang="nb-NO" dirty="0" smtClean="0"/>
                  </a:p>
                </p:txBody>
              </p:sp>
            </p:grpSp>
            <p:grpSp>
              <p:nvGrpSpPr>
                <p:cNvPr id="13" name="Group 12"/>
                <p:cNvGrpSpPr/>
                <p:nvPr/>
              </p:nvGrpSpPr>
              <p:grpSpPr>
                <a:xfrm>
                  <a:off x="4096678" y="380847"/>
                  <a:ext cx="3549396" cy="1234866"/>
                  <a:chOff x="4096678" y="380847"/>
                  <a:chExt cx="3549396" cy="1234866"/>
                </a:xfrm>
              </p:grpSpPr>
              <p:cxnSp>
                <p:nvCxnSpPr>
                  <p:cNvPr id="264" name="Straight Arrow Connector 263"/>
                  <p:cNvCxnSpPr/>
                  <p:nvPr/>
                </p:nvCxnSpPr>
                <p:spPr>
                  <a:xfrm>
                    <a:off x="5008967" y="1280036"/>
                    <a:ext cx="8668" cy="335677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4096678" y="380847"/>
                    <a:ext cx="3549396" cy="963883"/>
                    <a:chOff x="4096678" y="380847"/>
                    <a:chExt cx="3549396" cy="963883"/>
                  </a:xfrm>
                </p:grpSpPr>
                <p:sp>
                  <p:nvSpPr>
                    <p:cNvPr id="263" name="Rounded Rectangle 262"/>
                    <p:cNvSpPr/>
                    <p:nvPr/>
                  </p:nvSpPr>
                  <p:spPr>
                    <a:xfrm>
                      <a:off x="4096678" y="380847"/>
                      <a:ext cx="3549396" cy="963883"/>
                    </a:xfrm>
                    <a:prstGeom prst="roundRect">
                      <a:avLst/>
                    </a:prstGeom>
                    <a:solidFill>
                      <a:schemeClr val="bg1"/>
                    </a:solidFill>
                    <a:ln w="285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numCol="2" rtlCol="0" anchor="ctr"/>
                    <a:lstStyle/>
                    <a:p>
                      <a:pPr algn="ctr"/>
                      <a:endPara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nb-NO" sz="20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98.06</a:t>
                      </a:r>
                    </a:p>
                    <a:p>
                      <a:pPr algn="ctr"/>
                      <a:r>
                        <a:rPr lang="nb-NO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2)</a:t>
                      </a:r>
                      <a:endParaRPr lang="nb-NO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nb-NO" sz="20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98.12</a:t>
                      </a:r>
                      <a:endParaRPr lang="nb-NO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nb-NO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1)</a:t>
                      </a:r>
                    </a:p>
                  </p:txBody>
                </p:sp>
                <p:grpSp>
                  <p:nvGrpSpPr>
                    <p:cNvPr id="11" name="Group 10"/>
                    <p:cNvGrpSpPr/>
                    <p:nvPr/>
                  </p:nvGrpSpPr>
                  <p:grpSpPr>
                    <a:xfrm>
                      <a:off x="4168529" y="467798"/>
                      <a:ext cx="3413894" cy="697194"/>
                      <a:chOff x="4168529" y="467798"/>
                      <a:chExt cx="3413894" cy="697194"/>
                    </a:xfrm>
                  </p:grpSpPr>
                  <p:sp>
                    <p:nvSpPr>
                      <p:cNvPr id="281" name="Rounded Rectangle 280"/>
                      <p:cNvSpPr/>
                      <p:nvPr/>
                    </p:nvSpPr>
                    <p:spPr>
                      <a:xfrm>
                        <a:off x="4168529" y="467798"/>
                        <a:ext cx="1680877" cy="696137"/>
                      </a:xfrm>
                      <a:prstGeom prst="roundRect">
                        <a:avLst/>
                      </a:prstGeom>
                      <a:noFill/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82" name="Rounded Rectangle 281"/>
                      <p:cNvSpPr/>
                      <p:nvPr/>
                    </p:nvSpPr>
                    <p:spPr>
                      <a:xfrm>
                        <a:off x="5901546" y="468855"/>
                        <a:ext cx="1680877" cy="696137"/>
                      </a:xfrm>
                      <a:prstGeom prst="roundRect">
                        <a:avLst/>
                      </a:prstGeom>
                      <a:noFill/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</p:grpSp>
              <p:cxnSp>
                <p:nvCxnSpPr>
                  <p:cNvPr id="283" name="Straight Arrow Connector 282"/>
                  <p:cNvCxnSpPr/>
                  <p:nvPr/>
                </p:nvCxnSpPr>
                <p:spPr>
                  <a:xfrm>
                    <a:off x="6741984" y="1240146"/>
                    <a:ext cx="9201" cy="371169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08" name="Group 307"/>
                <p:cNvGrpSpPr/>
                <p:nvPr/>
              </p:nvGrpSpPr>
              <p:grpSpPr>
                <a:xfrm>
                  <a:off x="4160920" y="3087136"/>
                  <a:ext cx="3624710" cy="1962785"/>
                  <a:chOff x="4251496" y="2256674"/>
                  <a:chExt cx="3624710" cy="1962785"/>
                </a:xfrm>
              </p:grpSpPr>
              <p:cxnSp>
                <p:nvCxnSpPr>
                  <p:cNvPr id="309" name="Straight Arrow Connector 308"/>
                  <p:cNvCxnSpPr>
                    <a:stCxn id="313" idx="2"/>
                    <a:endCxn id="267" idx="0"/>
                  </p:cNvCxnSpPr>
                  <p:nvPr/>
                </p:nvCxnSpPr>
                <p:spPr>
                  <a:xfrm>
                    <a:off x="4649386" y="3542577"/>
                    <a:ext cx="1399624" cy="676882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10" name="Group 309"/>
                  <p:cNvGrpSpPr/>
                  <p:nvPr/>
                </p:nvGrpSpPr>
                <p:grpSpPr>
                  <a:xfrm>
                    <a:off x="4251496" y="2256674"/>
                    <a:ext cx="3624710" cy="1285903"/>
                    <a:chOff x="4251496" y="2256674"/>
                    <a:chExt cx="3624710" cy="1285903"/>
                  </a:xfrm>
                </p:grpSpPr>
                <p:sp>
                  <p:nvSpPr>
                    <p:cNvPr id="312" name="TextBox 311"/>
                    <p:cNvSpPr txBox="1"/>
                    <p:nvPr/>
                  </p:nvSpPr>
                  <p:spPr>
                    <a:xfrm>
                      <a:off x="4251496" y="2504921"/>
                      <a:ext cx="3624710" cy="64633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dirty="0" err="1" smtClean="0"/>
                        <a:t>Vehicle</a:t>
                      </a:r>
                      <a:r>
                        <a:rPr lang="nb-NO" dirty="0" smtClean="0"/>
                        <a:t>	CB-839	</a:t>
                      </a:r>
                      <a:r>
                        <a:rPr lang="nb-NO" dirty="0" err="1" smtClean="0"/>
                        <a:t>Vehicle</a:t>
                      </a:r>
                      <a:r>
                        <a:rPr lang="nb-NO" dirty="0" smtClean="0"/>
                        <a:t>	CB-839</a:t>
                      </a:r>
                    </a:p>
                    <a:p>
                      <a:r>
                        <a:rPr lang="nb-NO" dirty="0" smtClean="0"/>
                        <a:t>(n=6)	(n=6)	(n=6)	(n=5)</a:t>
                      </a:r>
                    </a:p>
                  </p:txBody>
                </p:sp>
                <p:sp>
                  <p:nvSpPr>
                    <p:cNvPr id="313" name="Rounded Rectangle 312"/>
                    <p:cNvSpPr/>
                    <p:nvPr/>
                  </p:nvSpPr>
                  <p:spPr>
                    <a:xfrm>
                      <a:off x="4251496" y="2566986"/>
                      <a:ext cx="795780" cy="975591"/>
                    </a:xfrm>
                    <a:prstGeom prst="roundRect">
                      <a:avLst/>
                    </a:prstGeom>
                    <a:noFill/>
                    <a:ln w="285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14" name="TextBox 313"/>
                    <p:cNvSpPr txBox="1"/>
                    <p:nvPr/>
                  </p:nvSpPr>
                  <p:spPr>
                    <a:xfrm>
                      <a:off x="4587502" y="2256674"/>
                      <a:ext cx="3010761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b="1" dirty="0" smtClean="0"/>
                        <a:t>MAS98.06		MAS98.12</a:t>
                      </a:r>
                      <a:endParaRPr lang="en-US" b="1" dirty="0"/>
                    </a:p>
                  </p:txBody>
                </p:sp>
                <p:sp>
                  <p:nvSpPr>
                    <p:cNvPr id="315" name="Rounded Rectangle 314"/>
                    <p:cNvSpPr/>
                    <p:nvPr/>
                  </p:nvSpPr>
                  <p:spPr>
                    <a:xfrm>
                      <a:off x="5161896" y="2554440"/>
                      <a:ext cx="795780" cy="988137"/>
                    </a:xfrm>
                    <a:prstGeom prst="roundRect">
                      <a:avLst/>
                    </a:prstGeom>
                    <a:noFill/>
                    <a:ln w="285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16" name="Rounded Rectangle 315"/>
                    <p:cNvSpPr/>
                    <p:nvPr/>
                  </p:nvSpPr>
                  <p:spPr>
                    <a:xfrm>
                      <a:off x="6122533" y="2554562"/>
                      <a:ext cx="795780" cy="988015"/>
                    </a:xfrm>
                    <a:prstGeom prst="roundRect">
                      <a:avLst/>
                    </a:prstGeom>
                    <a:noFill/>
                    <a:ln w="285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17" name="Rounded Rectangle 316"/>
                    <p:cNvSpPr/>
                    <p:nvPr/>
                  </p:nvSpPr>
                  <p:spPr>
                    <a:xfrm>
                      <a:off x="7010631" y="2554440"/>
                      <a:ext cx="795780" cy="988137"/>
                    </a:xfrm>
                    <a:prstGeom prst="roundRect">
                      <a:avLst/>
                    </a:prstGeom>
                    <a:noFill/>
                    <a:ln w="285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pic>
                  <p:nvPicPr>
                    <p:cNvPr id="318" name="Picture 317"/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6163874" y="3175208"/>
                      <a:ext cx="674568" cy="28449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19" name="Picture 318"/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7052448" y="3190891"/>
                      <a:ext cx="689809" cy="28966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20" name="Picture 319"/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4282405" y="3160490"/>
                      <a:ext cx="710673" cy="29842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21" name="Picture 320"/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5155307" y="3164692"/>
                      <a:ext cx="703022" cy="296492"/>
                    </a:xfrm>
                    <a:prstGeom prst="rect">
                      <a:avLst/>
                    </a:prstGeom>
                  </p:spPr>
                </p:pic>
              </p:grpSp>
              <p:cxnSp>
                <p:nvCxnSpPr>
                  <p:cNvPr id="311" name="Straight Arrow Connector 310"/>
                  <p:cNvCxnSpPr>
                    <a:stCxn id="317" idx="2"/>
                    <a:endCxn id="267" idx="0"/>
                  </p:cNvCxnSpPr>
                  <p:nvPr/>
                </p:nvCxnSpPr>
                <p:spPr>
                  <a:xfrm flipH="1">
                    <a:off x="6049010" y="3542577"/>
                    <a:ext cx="1359511" cy="676882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" name="Group 19"/>
                <p:cNvGrpSpPr/>
                <p:nvPr/>
              </p:nvGrpSpPr>
              <p:grpSpPr>
                <a:xfrm>
                  <a:off x="3948370" y="1717001"/>
                  <a:ext cx="4049809" cy="1350309"/>
                  <a:chOff x="3948370" y="1717001"/>
                  <a:chExt cx="4049809" cy="1350309"/>
                </a:xfrm>
              </p:grpSpPr>
              <p:grpSp>
                <p:nvGrpSpPr>
                  <p:cNvPr id="14" name="Group 13"/>
                  <p:cNvGrpSpPr/>
                  <p:nvPr/>
                </p:nvGrpSpPr>
                <p:grpSpPr>
                  <a:xfrm>
                    <a:off x="3948370" y="1717001"/>
                    <a:ext cx="4049809" cy="852816"/>
                    <a:chOff x="3948370" y="1717001"/>
                    <a:chExt cx="4049809" cy="852816"/>
                  </a:xfrm>
                </p:grpSpPr>
                <p:sp>
                  <p:nvSpPr>
                    <p:cNvPr id="265" name="Rounded Rectangle 264"/>
                    <p:cNvSpPr/>
                    <p:nvPr/>
                  </p:nvSpPr>
                  <p:spPr>
                    <a:xfrm>
                      <a:off x="3986400" y="1717001"/>
                      <a:ext cx="3935745" cy="852816"/>
                    </a:xfrm>
                    <a:prstGeom prst="roundRect">
                      <a:avLst/>
                    </a:prstGeom>
                    <a:noFill/>
                    <a:ln w="28575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numCol="2" rtlCol="0" anchor="ctr"/>
                    <a:lstStyle/>
                    <a:p>
                      <a:pPr algn="ctr"/>
                      <a:endPara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66" name="TextBox 265"/>
                    <p:cNvSpPr txBox="1"/>
                    <p:nvPr/>
                  </p:nvSpPr>
                  <p:spPr>
                    <a:xfrm>
                      <a:off x="3948370" y="1778058"/>
                      <a:ext cx="4049809" cy="6463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nb-NO" dirty="0" smtClean="0"/>
                        <a:t>CB-839 or </a:t>
                      </a:r>
                      <a:r>
                        <a:rPr lang="nb-NO" dirty="0" err="1" smtClean="0"/>
                        <a:t>vehicle</a:t>
                      </a:r>
                      <a:r>
                        <a:rPr lang="nb-NO" dirty="0" smtClean="0"/>
                        <a:t> </a:t>
                      </a:r>
                      <a:r>
                        <a:rPr lang="en-US" dirty="0"/>
                        <a:t>administered</a:t>
                      </a:r>
                      <a:r>
                        <a:rPr lang="nb-NO" dirty="0" smtClean="0"/>
                        <a:t> </a:t>
                      </a:r>
                      <a:r>
                        <a:rPr lang="nb-NO" dirty="0" err="1" smtClean="0"/>
                        <a:t>two</a:t>
                      </a:r>
                      <a:r>
                        <a:rPr lang="nb-NO" dirty="0" smtClean="0"/>
                        <a:t> times </a:t>
                      </a:r>
                      <a:r>
                        <a:rPr lang="nb-NO" dirty="0" err="1" smtClean="0"/>
                        <a:t>daily</a:t>
                      </a:r>
                      <a:r>
                        <a:rPr lang="nb-NO" dirty="0" smtClean="0"/>
                        <a:t> </a:t>
                      </a:r>
                      <a:r>
                        <a:rPr lang="nb-NO" dirty="0" err="1" smtClean="0"/>
                        <a:t>p.o</a:t>
                      </a:r>
                      <a:r>
                        <a:rPr lang="nb-NO" dirty="0" smtClean="0"/>
                        <a:t>. for </a:t>
                      </a:r>
                      <a:r>
                        <a:rPr lang="nb-NO" dirty="0" err="1" smtClean="0"/>
                        <a:t>two</a:t>
                      </a:r>
                      <a:r>
                        <a:rPr lang="nb-NO" dirty="0" smtClean="0"/>
                        <a:t> </a:t>
                      </a:r>
                      <a:r>
                        <a:rPr lang="nb-NO" dirty="0" err="1" smtClean="0"/>
                        <a:t>days</a:t>
                      </a:r>
                      <a:r>
                        <a:rPr lang="nb-NO" dirty="0" smtClean="0"/>
                        <a:t> (200mg/kg)</a:t>
                      </a:r>
                      <a:endParaRPr lang="en-US" dirty="0" smtClean="0"/>
                    </a:p>
                  </p:txBody>
                </p:sp>
              </p:grpSp>
              <p:grpSp>
                <p:nvGrpSpPr>
                  <p:cNvPr id="15" name="Group 14"/>
                  <p:cNvGrpSpPr/>
                  <p:nvPr/>
                </p:nvGrpSpPr>
                <p:grpSpPr>
                  <a:xfrm>
                    <a:off x="4915010" y="2619336"/>
                    <a:ext cx="1988031" cy="447974"/>
                    <a:chOff x="4915010" y="2619336"/>
                    <a:chExt cx="1988031" cy="447974"/>
                  </a:xfrm>
                </p:grpSpPr>
                <p:cxnSp>
                  <p:nvCxnSpPr>
                    <p:cNvPr id="322" name="Straight Arrow Connector 321"/>
                    <p:cNvCxnSpPr/>
                    <p:nvPr/>
                  </p:nvCxnSpPr>
                  <p:spPr>
                    <a:xfrm flipH="1">
                      <a:off x="4915010" y="2619336"/>
                      <a:ext cx="850117" cy="447974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3" name="Straight Arrow Connector 322"/>
                    <p:cNvCxnSpPr/>
                    <p:nvPr/>
                  </p:nvCxnSpPr>
                  <p:spPr>
                    <a:xfrm>
                      <a:off x="6101133" y="2638495"/>
                      <a:ext cx="801908" cy="414207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9" name="Group 18"/>
                <p:cNvGrpSpPr/>
                <p:nvPr/>
              </p:nvGrpSpPr>
              <p:grpSpPr>
                <a:xfrm>
                  <a:off x="4755246" y="5758278"/>
                  <a:ext cx="2396471" cy="2719355"/>
                  <a:chOff x="4755246" y="5758278"/>
                  <a:chExt cx="2396471" cy="2719355"/>
                </a:xfrm>
              </p:grpSpPr>
              <p:cxnSp>
                <p:nvCxnSpPr>
                  <p:cNvPr id="270" name="Straight Arrow Connector 269"/>
                  <p:cNvCxnSpPr>
                    <a:stCxn id="267" idx="2"/>
                    <a:endCxn id="269" idx="0"/>
                  </p:cNvCxnSpPr>
                  <p:nvPr/>
                </p:nvCxnSpPr>
                <p:spPr>
                  <a:xfrm flipH="1">
                    <a:off x="5953482" y="5758278"/>
                    <a:ext cx="4952" cy="500062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8" name="Group 17"/>
                  <p:cNvGrpSpPr/>
                  <p:nvPr/>
                </p:nvGrpSpPr>
                <p:grpSpPr>
                  <a:xfrm>
                    <a:off x="4755246" y="6258340"/>
                    <a:ext cx="2396471" cy="2219293"/>
                    <a:chOff x="4755246" y="6258340"/>
                    <a:chExt cx="2396471" cy="2219293"/>
                  </a:xfrm>
                </p:grpSpPr>
                <p:sp>
                  <p:nvSpPr>
                    <p:cNvPr id="269" name="Rounded Rectangle 268"/>
                    <p:cNvSpPr/>
                    <p:nvPr/>
                  </p:nvSpPr>
                  <p:spPr>
                    <a:xfrm>
                      <a:off x="4755246" y="6258340"/>
                      <a:ext cx="2396471" cy="2219293"/>
                    </a:xfrm>
                    <a:prstGeom prst="roundRect">
                      <a:avLst/>
                    </a:prstGeom>
                    <a:noFill/>
                    <a:ln w="28575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numCol="1" rtlCol="0" anchor="ctr"/>
                    <a:lstStyle/>
                    <a:p>
                      <a:pPr algn="ctr"/>
                      <a:endParaRPr lang="nb-NO" sz="2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nb-NO" sz="2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</a:t>
                      </a:r>
                    </a:p>
                    <a:p>
                      <a:pPr algn="ctr"/>
                      <a:r>
                        <a:rPr lang="nb-NO" sz="2000" b="1" baseline="30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nb-NO" sz="20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and </a:t>
                      </a:r>
                      <a:r>
                        <a:rPr lang="nb-NO" sz="2000" b="1" baseline="30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nb-NO" sz="20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 HR MAS MRS</a:t>
                      </a:r>
                      <a:endParaRPr lang="nb-NO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nb-NO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/>
                      <a:endParaRPr lang="nb-NO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nb-NO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pic>
                  <p:nvPicPr>
                    <p:cNvPr id="483" name="Picture 482"/>
                    <p:cNvPicPr>
                      <a:picLocks noChangeAspect="1"/>
                    </p:cNvPicPr>
                    <p:nvPr/>
                  </p:nvPicPr>
                  <p:blipFill rotWithShape="1">
                    <a:blip r:embed="rId7"/>
                    <a:srcRect l="13717" t="9819" r="13425" b="13120"/>
                    <a:stretch/>
                  </p:blipFill>
                  <p:spPr>
                    <a:xfrm>
                      <a:off x="4906422" y="7327900"/>
                      <a:ext cx="1972682" cy="1081210"/>
                    </a:xfrm>
                    <a:prstGeom prst="rect">
                      <a:avLst/>
                    </a:prstGeom>
                  </p:spPr>
                </p:pic>
              </p:grpSp>
            </p:grpSp>
          </p:grpSp>
        </p:grpSp>
      </p:grpSp>
      <p:grpSp>
        <p:nvGrpSpPr>
          <p:cNvPr id="451" name="Group 450"/>
          <p:cNvGrpSpPr/>
          <p:nvPr/>
        </p:nvGrpSpPr>
        <p:grpSpPr>
          <a:xfrm>
            <a:off x="105176" y="97763"/>
            <a:ext cx="5725771" cy="8467067"/>
            <a:chOff x="105176" y="97763"/>
            <a:chExt cx="5725771" cy="8467067"/>
          </a:xfrm>
        </p:grpSpPr>
        <p:sp>
          <p:nvSpPr>
            <p:cNvPr id="271" name="TextBox 270"/>
            <p:cNvSpPr txBox="1"/>
            <p:nvPr/>
          </p:nvSpPr>
          <p:spPr>
            <a:xfrm>
              <a:off x="1800850" y="97763"/>
              <a:ext cx="167225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 </a:t>
              </a:r>
              <a:r>
                <a:rPr lang="nb-NO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50" name="Group 449"/>
            <p:cNvGrpSpPr/>
            <p:nvPr/>
          </p:nvGrpSpPr>
          <p:grpSpPr>
            <a:xfrm>
              <a:off x="105176" y="523589"/>
              <a:ext cx="5725771" cy="8041241"/>
              <a:chOff x="105176" y="523589"/>
              <a:chExt cx="5725771" cy="8041241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762955" y="1699369"/>
                <a:ext cx="3912016" cy="1434989"/>
                <a:chOff x="8673684" y="1611072"/>
                <a:chExt cx="3912016" cy="1434989"/>
              </a:xfrm>
            </p:grpSpPr>
            <p:grpSp>
              <p:nvGrpSpPr>
                <p:cNvPr id="273" name="Group 272"/>
                <p:cNvGrpSpPr/>
                <p:nvPr/>
              </p:nvGrpSpPr>
              <p:grpSpPr>
                <a:xfrm>
                  <a:off x="8673684" y="1611072"/>
                  <a:ext cx="3912016" cy="998529"/>
                  <a:chOff x="8177662" y="1620952"/>
                  <a:chExt cx="3621406" cy="998529"/>
                </a:xfrm>
              </p:grpSpPr>
              <p:sp>
                <p:nvSpPr>
                  <p:cNvPr id="274" name="Rounded Rectangle 273"/>
                  <p:cNvSpPr/>
                  <p:nvPr/>
                </p:nvSpPr>
                <p:spPr>
                  <a:xfrm>
                    <a:off x="8177662" y="1620952"/>
                    <a:ext cx="3549396" cy="998529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>
                        <a:lumMod val="95000"/>
                        <a:lumOff val="5000"/>
                      </a:schemeClr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numCol="2" rtlCol="0" anchor="ctr"/>
                  <a:lstStyle/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75" name="Rectangle 274"/>
                  <p:cNvSpPr/>
                  <p:nvPr/>
                </p:nvSpPr>
                <p:spPr>
                  <a:xfrm>
                    <a:off x="8177662" y="1682167"/>
                    <a:ext cx="3621406" cy="923330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nb-NO" dirty="0" smtClean="0"/>
                      <a:t>CB-839 or </a:t>
                    </a:r>
                    <a:r>
                      <a:rPr lang="nb-NO" dirty="0" err="1" smtClean="0"/>
                      <a:t>vehicle</a:t>
                    </a:r>
                    <a:r>
                      <a:rPr lang="nb-NO" dirty="0" smtClean="0"/>
                      <a:t> </a:t>
                    </a:r>
                    <a:r>
                      <a:rPr lang="en-US" dirty="0"/>
                      <a:t>administered</a:t>
                    </a:r>
                    <a:r>
                      <a:rPr lang="nb-NO" dirty="0" smtClean="0"/>
                      <a:t> </a:t>
                    </a:r>
                    <a:r>
                      <a:rPr lang="nb-NO" dirty="0" err="1" smtClean="0"/>
                      <a:t>two</a:t>
                    </a:r>
                    <a:r>
                      <a:rPr lang="nb-NO" dirty="0" smtClean="0"/>
                      <a:t> times </a:t>
                    </a:r>
                    <a:r>
                      <a:rPr lang="nb-NO" dirty="0" err="1" smtClean="0"/>
                      <a:t>daily</a:t>
                    </a:r>
                    <a:r>
                      <a:rPr lang="nb-NO" dirty="0" smtClean="0"/>
                      <a:t> </a:t>
                    </a:r>
                    <a:r>
                      <a:rPr lang="nb-NO" dirty="0" err="1" smtClean="0"/>
                      <a:t>p.o</a:t>
                    </a:r>
                    <a:r>
                      <a:rPr lang="nb-NO" dirty="0" smtClean="0"/>
                      <a:t>. for 28 (MAS98.06) or 14 (MAS98.12) </a:t>
                    </a:r>
                    <a:r>
                      <a:rPr lang="nb-NO" dirty="0" err="1" smtClean="0"/>
                      <a:t>days</a:t>
                    </a:r>
                    <a:r>
                      <a:rPr lang="nb-NO" dirty="0" smtClean="0"/>
                      <a:t> (200mg/kg)</a:t>
                    </a:r>
                    <a:endParaRPr lang="en-US" dirty="0" smtClean="0"/>
                  </a:p>
                </p:txBody>
              </p:sp>
            </p:grpSp>
            <p:grpSp>
              <p:nvGrpSpPr>
                <p:cNvPr id="335" name="Group 334"/>
                <p:cNvGrpSpPr/>
                <p:nvPr/>
              </p:nvGrpSpPr>
              <p:grpSpPr>
                <a:xfrm>
                  <a:off x="9623769" y="2602229"/>
                  <a:ext cx="2178004" cy="443832"/>
                  <a:chOff x="5198564" y="2761270"/>
                  <a:chExt cx="2178004" cy="443832"/>
                </a:xfrm>
              </p:grpSpPr>
              <p:cxnSp>
                <p:nvCxnSpPr>
                  <p:cNvPr id="336" name="Straight Arrow Connector 335"/>
                  <p:cNvCxnSpPr>
                    <a:stCxn id="274" idx="2"/>
                  </p:cNvCxnSpPr>
                  <p:nvPr/>
                </p:nvCxnSpPr>
                <p:spPr>
                  <a:xfrm flipH="1">
                    <a:off x="5198564" y="2768642"/>
                    <a:ext cx="967029" cy="43420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7" name="Straight Arrow Connector 336"/>
                  <p:cNvCxnSpPr/>
                  <p:nvPr/>
                </p:nvCxnSpPr>
                <p:spPr>
                  <a:xfrm>
                    <a:off x="6274185" y="2761270"/>
                    <a:ext cx="1102383" cy="443832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" name="Group 3"/>
              <p:cNvGrpSpPr/>
              <p:nvPr/>
            </p:nvGrpSpPr>
            <p:grpSpPr>
              <a:xfrm>
                <a:off x="983844" y="523589"/>
                <a:ext cx="3558536" cy="1136141"/>
                <a:chOff x="8299488" y="435292"/>
                <a:chExt cx="3558536" cy="1136141"/>
              </a:xfrm>
            </p:grpSpPr>
            <p:cxnSp>
              <p:nvCxnSpPr>
                <p:cNvPr id="272" name="Straight Arrow Connector 271"/>
                <p:cNvCxnSpPr/>
                <p:nvPr/>
              </p:nvCxnSpPr>
              <p:spPr>
                <a:xfrm flipH="1">
                  <a:off x="9223461" y="1260578"/>
                  <a:ext cx="417" cy="303987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38" name="Group 337"/>
                <p:cNvGrpSpPr/>
                <p:nvPr/>
              </p:nvGrpSpPr>
              <p:grpSpPr>
                <a:xfrm>
                  <a:off x="8299488" y="435292"/>
                  <a:ext cx="3558536" cy="800305"/>
                  <a:chOff x="8166138" y="435292"/>
                  <a:chExt cx="3558536" cy="800305"/>
                </a:xfrm>
              </p:grpSpPr>
              <p:sp>
                <p:nvSpPr>
                  <p:cNvPr id="339" name="Rounded Rectangle 338"/>
                  <p:cNvSpPr/>
                  <p:nvPr/>
                </p:nvSpPr>
                <p:spPr>
                  <a:xfrm>
                    <a:off x="8166138" y="435292"/>
                    <a:ext cx="3549396" cy="80030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2857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numCol="2" rtlCol="0" anchor="ctr"/>
                  <a:lstStyle/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S98.06</a:t>
                    </a:r>
                  </a:p>
                  <a:p>
                    <a:pPr algn="ctr"/>
                    <a:r>
                      <a:rPr lang="nb-NO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n=9)</a:t>
                    </a:r>
                    <a:endParaRPr lang="nb-NO" sz="12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S98.12</a:t>
                    </a:r>
                    <a:endParaRPr lang="nb-NO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nb-NO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n=9)</a:t>
                    </a:r>
                  </a:p>
                </p:txBody>
              </p:sp>
              <p:sp>
                <p:nvSpPr>
                  <p:cNvPr id="340" name="Rounded Rectangle 339"/>
                  <p:cNvSpPr/>
                  <p:nvPr/>
                </p:nvSpPr>
                <p:spPr>
                  <a:xfrm>
                    <a:off x="8271072" y="476175"/>
                    <a:ext cx="1680877" cy="696137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41" name="Rounded Rectangle 340"/>
                  <p:cNvSpPr/>
                  <p:nvPr/>
                </p:nvSpPr>
                <p:spPr>
                  <a:xfrm>
                    <a:off x="10043797" y="465283"/>
                    <a:ext cx="1680877" cy="696137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cxnSp>
              <p:nvCxnSpPr>
                <p:cNvPr id="342" name="Straight Arrow Connector 341"/>
                <p:cNvCxnSpPr/>
                <p:nvPr/>
              </p:nvCxnSpPr>
              <p:spPr>
                <a:xfrm flipH="1">
                  <a:off x="10802368" y="1267446"/>
                  <a:ext cx="417" cy="303987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9" name="Group 448"/>
              <p:cNvGrpSpPr/>
              <p:nvPr/>
            </p:nvGrpSpPr>
            <p:grpSpPr>
              <a:xfrm>
                <a:off x="105176" y="6254245"/>
                <a:ext cx="5725771" cy="2310585"/>
                <a:chOff x="105176" y="6254245"/>
                <a:chExt cx="5725771" cy="2310585"/>
              </a:xfrm>
            </p:grpSpPr>
            <p:grpSp>
              <p:nvGrpSpPr>
                <p:cNvPr id="349" name="Group 348"/>
                <p:cNvGrpSpPr/>
                <p:nvPr/>
              </p:nvGrpSpPr>
              <p:grpSpPr>
                <a:xfrm>
                  <a:off x="1886190" y="6258297"/>
                  <a:ext cx="1802997" cy="2294045"/>
                  <a:chOff x="8325848" y="6183588"/>
                  <a:chExt cx="1802997" cy="2294045"/>
                </a:xfrm>
              </p:grpSpPr>
              <p:sp>
                <p:nvSpPr>
                  <p:cNvPr id="350" name="Rounded Rectangle 349"/>
                  <p:cNvSpPr/>
                  <p:nvPr/>
                </p:nvSpPr>
                <p:spPr>
                  <a:xfrm>
                    <a:off x="8325848" y="6183588"/>
                    <a:ext cx="1802997" cy="229404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28575">
                    <a:solidFill>
                      <a:schemeClr val="tx1">
                        <a:lumMod val="95000"/>
                        <a:lumOff val="5000"/>
                      </a:schemeClr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numCol="1" rtlCol="0" anchor="ctr"/>
                  <a:lstStyle/>
                  <a:p>
                    <a:pPr algn="ctr"/>
                    <a:r>
                      <a:rPr lang="nb-NO" sz="2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umor </a:t>
                    </a:r>
                  </a:p>
                  <a:p>
                    <a:pPr algn="ctr"/>
                    <a:r>
                      <a: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HC</a:t>
                    </a:r>
                  </a:p>
                  <a:p>
                    <a:pPr algn="ctr"/>
                    <a:r>
                      <a:rPr lang="nb-NO" sz="16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even </a:t>
                    </a:r>
                    <a:r>
                      <a:rPr lang="nb-NO" sz="1600" dirty="0" err="1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elected</a:t>
                    </a:r>
                    <a:r>
                      <a:rPr lang="nb-NO" sz="1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proteins</a:t>
                    </a:r>
                    <a:endParaRPr lang="nb-NO" sz="20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nb-NO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</a:p>
                  <a:p>
                    <a:pPr algn="ctr"/>
                    <a:endParaRPr lang="nb-NO" sz="12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12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351" name="Picture 350"/>
                  <p:cNvPicPr>
                    <a:picLocks noChangeAspect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585238" y="7383563"/>
                    <a:ext cx="1240850" cy="97321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352" name="Group 351"/>
                <p:cNvGrpSpPr/>
                <p:nvPr/>
              </p:nvGrpSpPr>
              <p:grpSpPr>
                <a:xfrm>
                  <a:off x="105176" y="6270785"/>
                  <a:ext cx="1688238" cy="2294045"/>
                  <a:chOff x="10630876" y="6131302"/>
                  <a:chExt cx="1688238" cy="2294045"/>
                </a:xfrm>
              </p:grpSpPr>
              <p:sp>
                <p:nvSpPr>
                  <p:cNvPr id="353" name="Rounded Rectangle 352"/>
                  <p:cNvSpPr/>
                  <p:nvPr/>
                </p:nvSpPr>
                <p:spPr>
                  <a:xfrm>
                    <a:off x="10630876" y="6131302"/>
                    <a:ext cx="1688238" cy="229404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28575">
                    <a:solidFill>
                      <a:schemeClr val="tx1">
                        <a:lumMod val="95000"/>
                        <a:lumOff val="5000"/>
                      </a:schemeClr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numCol="1" rtlCol="0" anchor="ctr"/>
                  <a:lstStyle/>
                  <a:p>
                    <a:pPr algn="ctr"/>
                    <a:r>
                      <a:rPr lang="nb-NO" sz="20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umor </a:t>
                    </a:r>
                  </a:p>
                  <a:p>
                    <a:pPr algn="ctr"/>
                    <a:r>
                      <a:rPr lang="nb-NO" sz="2000" b="1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rowth </a:t>
                    </a:r>
                    <a:r>
                      <a:rPr lang="nb-NO" sz="2000" b="1" dirty="0" err="1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nalysis</a:t>
                    </a:r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20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nb-NO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</a:p>
                  <a:p>
                    <a:pPr algn="ctr"/>
                    <a:endParaRPr lang="nb-NO" sz="12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12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354" name="Picture 353"/>
                  <p:cNvPicPr>
                    <a:picLocks noChangeAspect="1"/>
                  </p:cNvPicPr>
                  <p:nvPr/>
                </p:nvPicPr>
                <p:blipFill rotWithShape="1"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61" t="18140" r="62533" b="7168"/>
                  <a:stretch/>
                </p:blipFill>
                <p:spPr>
                  <a:xfrm>
                    <a:off x="10894227" y="7161549"/>
                    <a:ext cx="1124946" cy="1195229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479" name="Group 478"/>
                <p:cNvGrpSpPr/>
                <p:nvPr/>
              </p:nvGrpSpPr>
              <p:grpSpPr>
                <a:xfrm>
                  <a:off x="3778740" y="6254245"/>
                  <a:ext cx="2052207" cy="2294045"/>
                  <a:chOff x="11931677" y="6194976"/>
                  <a:chExt cx="2052207" cy="2294045"/>
                </a:xfrm>
              </p:grpSpPr>
              <p:sp>
                <p:nvSpPr>
                  <p:cNvPr id="480" name="Rounded Rectangle 479"/>
                  <p:cNvSpPr/>
                  <p:nvPr/>
                </p:nvSpPr>
                <p:spPr>
                  <a:xfrm>
                    <a:off x="11931677" y="6194976"/>
                    <a:ext cx="2052207" cy="229404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28575">
                    <a:solidFill>
                      <a:schemeClr val="tx1">
                        <a:lumMod val="95000"/>
                        <a:lumOff val="5000"/>
                      </a:schemeClr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numCol="1" rtlCol="0" anchor="ctr"/>
                  <a:lstStyle/>
                  <a:p>
                    <a:pPr algn="ctr"/>
                    <a:endParaRPr lang="nb-NO" sz="20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nb-NO" sz="2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umor </a:t>
                    </a:r>
                  </a:p>
                  <a:p>
                    <a:pPr algn="ctr"/>
                    <a:r>
                      <a:rPr lang="nb-NO" sz="2000" b="1" baseline="30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3</a:t>
                    </a:r>
                    <a:r>
                      <a: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 and </a:t>
                    </a:r>
                    <a:r>
                      <a:rPr lang="nb-NO" sz="2000" b="1" baseline="30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r>
                      <a:rPr lang="nb-NO" sz="20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 HR MAS MRS </a:t>
                    </a:r>
                  </a:p>
                  <a:p>
                    <a:pPr algn="ctr"/>
                    <a:r>
                      <a:rPr lang="nb-NO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N.A. </a:t>
                    </a:r>
                    <a:r>
                      <a:rPr lang="nb-NO" dirty="0" err="1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nly</a:t>
                    </a:r>
                    <a:r>
                      <a:rPr lang="nb-NO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)</a:t>
                    </a:r>
                  </a:p>
                  <a:p>
                    <a:pPr algn="ctr"/>
                    <a:endParaRPr lang="nb-NO" sz="20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2000" b="1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nb-NO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</a:p>
                  <a:p>
                    <a:pPr algn="ctr"/>
                    <a:endParaRPr lang="nb-NO" sz="12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nb-NO" sz="12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481" name="Picture 480"/>
                  <p:cNvPicPr>
                    <a:picLocks noChangeAspect="1"/>
                  </p:cNvPicPr>
                  <p:nvPr/>
                </p:nvPicPr>
                <p:blipFill rotWithShape="1">
                  <a:blip r:embed="rId7"/>
                  <a:srcRect l="13717" t="9819" r="13425" b="13120"/>
                  <a:stretch/>
                </p:blipFill>
                <p:spPr>
                  <a:xfrm>
                    <a:off x="12038175" y="7412396"/>
                    <a:ext cx="1839211" cy="1008056"/>
                  </a:xfrm>
                  <a:prstGeom prst="rect">
                    <a:avLst/>
                  </a:prstGeom>
                </p:spPr>
              </p:pic>
            </p:grpSp>
          </p:grpSp>
          <p:grpSp>
            <p:nvGrpSpPr>
              <p:cNvPr id="7" name="Group 6"/>
              <p:cNvGrpSpPr/>
              <p:nvPr/>
            </p:nvGrpSpPr>
            <p:grpSpPr>
              <a:xfrm>
                <a:off x="917624" y="3124310"/>
                <a:ext cx="3887220" cy="3146475"/>
                <a:chOff x="8828353" y="3036013"/>
                <a:chExt cx="3887220" cy="3146475"/>
              </a:xfrm>
            </p:grpSpPr>
            <p:grpSp>
              <p:nvGrpSpPr>
                <p:cNvPr id="324" name="Group 323"/>
                <p:cNvGrpSpPr/>
                <p:nvPr/>
              </p:nvGrpSpPr>
              <p:grpSpPr>
                <a:xfrm>
                  <a:off x="8828353" y="3036013"/>
                  <a:ext cx="3624710" cy="1298398"/>
                  <a:chOff x="4251496" y="2244179"/>
                  <a:chExt cx="3624710" cy="1298398"/>
                </a:xfrm>
              </p:grpSpPr>
              <p:sp>
                <p:nvSpPr>
                  <p:cNvPr id="325" name="TextBox 324"/>
                  <p:cNvSpPr txBox="1"/>
                  <p:nvPr/>
                </p:nvSpPr>
                <p:spPr>
                  <a:xfrm>
                    <a:off x="4251496" y="2504921"/>
                    <a:ext cx="3624710" cy="6463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dirty="0" err="1" smtClean="0"/>
                      <a:t>Vehicle</a:t>
                    </a:r>
                    <a:r>
                      <a:rPr lang="nb-NO" dirty="0" smtClean="0"/>
                      <a:t>	CB-839	</a:t>
                    </a:r>
                    <a:r>
                      <a:rPr lang="nb-NO" dirty="0" err="1" smtClean="0"/>
                      <a:t>Vehicle</a:t>
                    </a:r>
                    <a:r>
                      <a:rPr lang="nb-NO" dirty="0" smtClean="0"/>
                      <a:t>	CB-839</a:t>
                    </a:r>
                  </a:p>
                  <a:p>
                    <a:r>
                      <a:rPr lang="nb-NO" dirty="0" smtClean="0"/>
                      <a:t>(n=5)	(n=4)	(n=5)	(n=4)</a:t>
                    </a:r>
                  </a:p>
                </p:txBody>
              </p:sp>
              <p:sp>
                <p:nvSpPr>
                  <p:cNvPr id="326" name="Rounded Rectangle 325"/>
                  <p:cNvSpPr/>
                  <p:nvPr/>
                </p:nvSpPr>
                <p:spPr>
                  <a:xfrm>
                    <a:off x="4251496" y="2566986"/>
                    <a:ext cx="795780" cy="975591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27" name="TextBox 326"/>
                  <p:cNvSpPr txBox="1"/>
                  <p:nvPr/>
                </p:nvSpPr>
                <p:spPr>
                  <a:xfrm>
                    <a:off x="4549170" y="2244179"/>
                    <a:ext cx="3010761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b="1" dirty="0" smtClean="0"/>
                      <a:t>MAS98.06		MAS98.12</a:t>
                    </a:r>
                    <a:endParaRPr lang="en-US" b="1" dirty="0"/>
                  </a:p>
                </p:txBody>
              </p:sp>
              <p:sp>
                <p:nvSpPr>
                  <p:cNvPr id="328" name="Rounded Rectangle 327"/>
                  <p:cNvSpPr/>
                  <p:nvPr/>
                </p:nvSpPr>
                <p:spPr>
                  <a:xfrm>
                    <a:off x="5161896" y="2554440"/>
                    <a:ext cx="795780" cy="988137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29" name="Rounded Rectangle 328"/>
                  <p:cNvSpPr/>
                  <p:nvPr/>
                </p:nvSpPr>
                <p:spPr>
                  <a:xfrm>
                    <a:off x="6122533" y="2554562"/>
                    <a:ext cx="795780" cy="988015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30" name="Rounded Rectangle 329"/>
                  <p:cNvSpPr/>
                  <p:nvPr/>
                </p:nvSpPr>
                <p:spPr>
                  <a:xfrm>
                    <a:off x="7010631" y="2554440"/>
                    <a:ext cx="795780" cy="988137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pic>
                <p:nvPicPr>
                  <p:cNvPr id="331" name="Picture 330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6163874" y="3175208"/>
                    <a:ext cx="674568" cy="284492"/>
                  </a:xfrm>
                  <a:prstGeom prst="rect">
                    <a:avLst/>
                  </a:prstGeom>
                </p:spPr>
              </p:pic>
              <p:pic>
                <p:nvPicPr>
                  <p:cNvPr id="332" name="Picture 331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7052448" y="3190891"/>
                    <a:ext cx="689809" cy="289660"/>
                  </a:xfrm>
                  <a:prstGeom prst="rect">
                    <a:avLst/>
                  </a:prstGeom>
                </p:spPr>
              </p:pic>
              <p:pic>
                <p:nvPicPr>
                  <p:cNvPr id="333" name="Picture 332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4282405" y="3160490"/>
                    <a:ext cx="710673" cy="298421"/>
                  </a:xfrm>
                  <a:prstGeom prst="rect">
                    <a:avLst/>
                  </a:prstGeom>
                </p:spPr>
              </p:pic>
              <p:pic>
                <p:nvPicPr>
                  <p:cNvPr id="334" name="Picture 333"/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5155307" y="3164692"/>
                    <a:ext cx="703022" cy="296492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" name="Group 5"/>
                <p:cNvGrpSpPr/>
                <p:nvPr/>
              </p:nvGrpSpPr>
              <p:grpSpPr>
                <a:xfrm>
                  <a:off x="8860024" y="4334411"/>
                  <a:ext cx="3855549" cy="1848077"/>
                  <a:chOff x="8860024" y="4334411"/>
                  <a:chExt cx="3855549" cy="1848077"/>
                </a:xfrm>
              </p:grpSpPr>
              <p:grpSp>
                <p:nvGrpSpPr>
                  <p:cNvPr id="3" name="Group 2"/>
                  <p:cNvGrpSpPr/>
                  <p:nvPr/>
                </p:nvGrpSpPr>
                <p:grpSpPr>
                  <a:xfrm>
                    <a:off x="8860024" y="4334411"/>
                    <a:ext cx="3855549" cy="1848077"/>
                    <a:chOff x="8860024" y="4334411"/>
                    <a:chExt cx="3855549" cy="1848077"/>
                  </a:xfrm>
                </p:grpSpPr>
                <p:cxnSp>
                  <p:nvCxnSpPr>
                    <p:cNvPr id="343" name="Straight Arrow Connector 342"/>
                    <p:cNvCxnSpPr>
                      <a:stCxn id="326" idx="2"/>
                      <a:endCxn id="350" idx="0"/>
                    </p:cNvCxnSpPr>
                    <p:nvPr/>
                  </p:nvCxnSpPr>
                  <p:spPr>
                    <a:xfrm>
                      <a:off x="9226243" y="4334411"/>
                      <a:ext cx="1472175" cy="1835589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4" name="Straight Arrow Connector 343"/>
                    <p:cNvCxnSpPr>
                      <a:stCxn id="329" idx="2"/>
                      <a:endCxn id="350" idx="0"/>
                    </p:cNvCxnSpPr>
                    <p:nvPr/>
                  </p:nvCxnSpPr>
                  <p:spPr>
                    <a:xfrm flipH="1">
                      <a:off x="10698418" y="4334411"/>
                      <a:ext cx="398862" cy="1835589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5" name="Straight Arrow Connector 344"/>
                    <p:cNvCxnSpPr>
                      <a:stCxn id="326" idx="2"/>
                      <a:endCxn id="353" idx="0"/>
                    </p:cNvCxnSpPr>
                    <p:nvPr/>
                  </p:nvCxnSpPr>
                  <p:spPr>
                    <a:xfrm flipH="1">
                      <a:off x="8860024" y="4334411"/>
                      <a:ext cx="366219" cy="1848077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6" name="Straight Arrow Connector 345"/>
                    <p:cNvCxnSpPr>
                      <a:stCxn id="328" idx="2"/>
                      <a:endCxn id="353" idx="0"/>
                    </p:cNvCxnSpPr>
                    <p:nvPr/>
                  </p:nvCxnSpPr>
                  <p:spPr>
                    <a:xfrm flipH="1">
                      <a:off x="8860024" y="4334411"/>
                      <a:ext cx="1276619" cy="1848077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7" name="Straight Arrow Connector 346"/>
                    <p:cNvCxnSpPr>
                      <a:stCxn id="329" idx="2"/>
                      <a:endCxn id="353" idx="0"/>
                    </p:cNvCxnSpPr>
                    <p:nvPr/>
                  </p:nvCxnSpPr>
                  <p:spPr>
                    <a:xfrm flipH="1">
                      <a:off x="8860024" y="4334411"/>
                      <a:ext cx="2237256" cy="1848077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8" name="Straight Arrow Connector 347"/>
                    <p:cNvCxnSpPr>
                      <a:stCxn id="330" idx="2"/>
                      <a:endCxn id="353" idx="0"/>
                    </p:cNvCxnSpPr>
                    <p:nvPr/>
                  </p:nvCxnSpPr>
                  <p:spPr>
                    <a:xfrm flipH="1">
                      <a:off x="8860024" y="4334411"/>
                      <a:ext cx="3125354" cy="1848077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4" name="Straight Arrow Connector 483"/>
                    <p:cNvCxnSpPr>
                      <a:stCxn id="326" idx="2"/>
                      <a:endCxn id="480" idx="0"/>
                    </p:cNvCxnSpPr>
                    <p:nvPr/>
                  </p:nvCxnSpPr>
                  <p:spPr>
                    <a:xfrm>
                      <a:off x="9226243" y="4334411"/>
                      <a:ext cx="3489330" cy="1831537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485" name="Straight Arrow Connector 484"/>
                  <p:cNvCxnSpPr>
                    <a:stCxn id="329" idx="2"/>
                    <a:endCxn id="480" idx="0"/>
                  </p:cNvCxnSpPr>
                  <p:nvPr/>
                </p:nvCxnSpPr>
                <p:spPr>
                  <a:xfrm>
                    <a:off x="11097280" y="4334411"/>
                    <a:ext cx="1618293" cy="1831537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185655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8</Words>
  <Application>Microsoft Office PowerPoint</Application>
  <PresentationFormat>Custom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NTN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Tunset Grinde</dc:creator>
  <cp:lastModifiedBy>Maria Tunset Grinde</cp:lastModifiedBy>
  <cp:revision>38</cp:revision>
  <dcterms:created xsi:type="dcterms:W3CDTF">2018-04-03T11:28:52Z</dcterms:created>
  <dcterms:modified xsi:type="dcterms:W3CDTF">2019-03-25T10:44:40Z</dcterms:modified>
</cp:coreProperties>
</file>